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F5AA8"/>
    <a:srgbClr val="5596E6"/>
    <a:srgbClr val="1CCDCD"/>
    <a:srgbClr val="FFC4E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5" autoAdjust="0"/>
    <p:restoredTop sz="94660"/>
  </p:normalViewPr>
  <p:slideViewPr>
    <p:cSldViewPr snapToGrid="0">
      <p:cViewPr varScale="1">
        <p:scale>
          <a:sx n="63" d="100"/>
          <a:sy n="63" d="100"/>
        </p:scale>
        <p:origin x="348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F7814-201D-4194-BF8C-3FB8A91189E9}" type="datetimeFigureOut">
              <a:rPr lang="nl-NL" smtClean="0"/>
              <a:t>19-12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A35DAD-5536-4491-9ECF-CAE3A4C10FF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64956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F7814-201D-4194-BF8C-3FB8A91189E9}" type="datetimeFigureOut">
              <a:rPr lang="nl-NL" smtClean="0"/>
              <a:t>19-12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A35DAD-5536-4491-9ECF-CAE3A4C10FF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83548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F7814-201D-4194-BF8C-3FB8A91189E9}" type="datetimeFigureOut">
              <a:rPr lang="nl-NL" smtClean="0"/>
              <a:t>19-12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A35DAD-5536-4491-9ECF-CAE3A4C10FF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433250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F7814-201D-4194-BF8C-3FB8A91189E9}" type="datetimeFigureOut">
              <a:rPr lang="nl-NL" smtClean="0"/>
              <a:t>19-12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A35DAD-5536-4491-9ECF-CAE3A4C10FF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747615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F7814-201D-4194-BF8C-3FB8A91189E9}" type="datetimeFigureOut">
              <a:rPr lang="nl-NL" smtClean="0"/>
              <a:t>19-12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A35DAD-5536-4491-9ECF-CAE3A4C10FF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73966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F7814-201D-4194-BF8C-3FB8A91189E9}" type="datetimeFigureOut">
              <a:rPr lang="nl-NL" smtClean="0"/>
              <a:t>19-12-2021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A35DAD-5536-4491-9ECF-CAE3A4C10FF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05708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F7814-201D-4194-BF8C-3FB8A91189E9}" type="datetimeFigureOut">
              <a:rPr lang="nl-NL" smtClean="0"/>
              <a:t>19-12-2021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A35DAD-5536-4491-9ECF-CAE3A4C10FF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99424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F7814-201D-4194-BF8C-3FB8A91189E9}" type="datetimeFigureOut">
              <a:rPr lang="nl-NL" smtClean="0"/>
              <a:t>19-12-2021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A35DAD-5536-4491-9ECF-CAE3A4C10FF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07009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F7814-201D-4194-BF8C-3FB8A91189E9}" type="datetimeFigureOut">
              <a:rPr lang="nl-NL" smtClean="0"/>
              <a:t>19-12-2021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A35DAD-5536-4491-9ECF-CAE3A4C10FF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79677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F7814-201D-4194-BF8C-3FB8A91189E9}" type="datetimeFigureOut">
              <a:rPr lang="nl-NL" smtClean="0"/>
              <a:t>19-12-2021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A35DAD-5536-4491-9ECF-CAE3A4C10FF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41458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F7814-201D-4194-BF8C-3FB8A91189E9}" type="datetimeFigureOut">
              <a:rPr lang="nl-NL" smtClean="0"/>
              <a:t>19-12-2021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A35DAD-5536-4491-9ECF-CAE3A4C10FF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69599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3F7814-201D-4194-BF8C-3FB8A91189E9}" type="datetimeFigureOut">
              <a:rPr lang="nl-NL" smtClean="0"/>
              <a:t>19-12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A35DAD-5536-4491-9ECF-CAE3A4C10FF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250357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CA3D6C26-145F-40AA-A90E-52CDF1BE4E0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152" b="10717"/>
          <a:stretch/>
        </p:blipFill>
        <p:spPr>
          <a:xfrm>
            <a:off x="3539141" y="1625683"/>
            <a:ext cx="3057859" cy="1856063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24DC6CC1-EDED-424A-A12E-4772D2458862}"/>
              </a:ext>
            </a:extLst>
          </p:cNvPr>
          <p:cNvSpPr txBox="1"/>
          <p:nvPr/>
        </p:nvSpPr>
        <p:spPr>
          <a:xfrm>
            <a:off x="761999" y="471750"/>
            <a:ext cx="56739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digital </a:t>
            </a:r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content 5</a:t>
            </a:r>
            <a:endParaRPr lang="nl-N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28FB6530-9C97-4413-8D5B-BA6F2A865354}"/>
              </a:ext>
            </a:extLst>
          </p:cNvPr>
          <p:cNvSpPr txBox="1"/>
          <p:nvPr/>
        </p:nvSpPr>
        <p:spPr>
          <a:xfrm>
            <a:off x="1058635" y="10831038"/>
            <a:ext cx="20746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emoglobin (mmol/L) 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82E9D1E4-CF98-4F10-9001-FBD5EBC90706}"/>
              </a:ext>
            </a:extLst>
          </p:cNvPr>
          <p:cNvSpPr txBox="1"/>
          <p:nvPr/>
        </p:nvSpPr>
        <p:spPr>
          <a:xfrm>
            <a:off x="1077993" y="5554001"/>
            <a:ext cx="16482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odium (mmol/L)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8A9CCE87-E040-4263-A23A-DCE523C7281F}"/>
              </a:ext>
            </a:extLst>
          </p:cNvPr>
          <p:cNvSpPr txBox="1"/>
          <p:nvPr/>
        </p:nvSpPr>
        <p:spPr>
          <a:xfrm>
            <a:off x="1374370" y="3388077"/>
            <a:ext cx="13901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Urea (mmol/L)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DEED801-BCB6-49C9-8EE4-C6C7D0BFF00B}"/>
              </a:ext>
            </a:extLst>
          </p:cNvPr>
          <p:cNvSpPr txBox="1"/>
          <p:nvPr/>
        </p:nvSpPr>
        <p:spPr>
          <a:xfrm>
            <a:off x="4182768" y="3396920"/>
            <a:ext cx="18053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reatinine (</a:t>
            </a:r>
            <a:r>
              <a:rPr lang="en-GB" sz="1400" b="1" dirty="0"/>
              <a:t>μ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21D17C3C-38C8-4EFA-9D95-6F701138109B}"/>
              </a:ext>
            </a:extLst>
          </p:cNvPr>
          <p:cNvSpPr txBox="1"/>
          <p:nvPr/>
        </p:nvSpPr>
        <p:spPr>
          <a:xfrm>
            <a:off x="1881927" y="5866984"/>
            <a:ext cx="32755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iomarkers of inflammation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CDDAB05F-3C79-48AE-99B9-7D729DC1DA35}"/>
              </a:ext>
            </a:extLst>
          </p:cNvPr>
          <p:cNvSpPr txBox="1"/>
          <p:nvPr/>
        </p:nvSpPr>
        <p:spPr>
          <a:xfrm>
            <a:off x="967293" y="8096381"/>
            <a:ext cx="1996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eukocytes (x10^9/L)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D2263540-4EC9-415B-B922-F48D354202AE}"/>
              </a:ext>
            </a:extLst>
          </p:cNvPr>
          <p:cNvSpPr txBox="1"/>
          <p:nvPr/>
        </p:nvSpPr>
        <p:spPr>
          <a:xfrm>
            <a:off x="4733082" y="8081141"/>
            <a:ext cx="11576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RP (mg/L)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0124F43D-65EA-48EC-87B2-F866E3CFB024}"/>
              </a:ext>
            </a:extLst>
          </p:cNvPr>
          <p:cNvSpPr txBox="1"/>
          <p:nvPr/>
        </p:nvSpPr>
        <p:spPr>
          <a:xfrm>
            <a:off x="4523661" y="10852010"/>
            <a:ext cx="16161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actate (mmol/L)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5CD41D6B-E372-4685-86AC-921A3704AE51}"/>
              </a:ext>
            </a:extLst>
          </p:cNvPr>
          <p:cNvSpPr txBox="1"/>
          <p:nvPr/>
        </p:nvSpPr>
        <p:spPr>
          <a:xfrm>
            <a:off x="1901576" y="8503424"/>
            <a:ext cx="37793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iomarkers of circulation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9809E1D-573B-4947-89F2-4AC6534BB0B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382" b="13466"/>
          <a:stretch/>
        </p:blipFill>
        <p:spPr>
          <a:xfrm>
            <a:off x="248301" y="1572713"/>
            <a:ext cx="3290840" cy="186124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3F6BAA0-12F2-4247-AC09-0799FDA2C1D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140" r="3807" b="12979"/>
          <a:stretch/>
        </p:blipFill>
        <p:spPr>
          <a:xfrm>
            <a:off x="157442" y="6157409"/>
            <a:ext cx="3271557" cy="201115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A9547A7-5784-4736-8158-6C7B7777BAB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140" r="1961" b="13522"/>
          <a:stretch/>
        </p:blipFill>
        <p:spPr>
          <a:xfrm>
            <a:off x="195547" y="3621356"/>
            <a:ext cx="3427414" cy="195891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A5EFDF89-3527-49B9-A61A-2AE59DA3540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6361" t="9002" r="8240" b="49202"/>
          <a:stretch/>
        </p:blipFill>
        <p:spPr>
          <a:xfrm>
            <a:off x="4182768" y="3772025"/>
            <a:ext cx="1056018" cy="177378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5E8F8E8-262F-448C-B44D-5DF107329EC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1901" r="2852" b="13721"/>
          <a:stretch/>
        </p:blipFill>
        <p:spPr>
          <a:xfrm>
            <a:off x="3539141" y="6174761"/>
            <a:ext cx="3069976" cy="197211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6A72B10F-31D0-428E-A585-2CB062A8C83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049" r="3636" b="12879"/>
          <a:stretch/>
        </p:blipFill>
        <p:spPr>
          <a:xfrm>
            <a:off x="165063" y="8794643"/>
            <a:ext cx="3263937" cy="2057367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4383CDF8-F836-48F8-BC72-DF7AFA75D6B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5555" b="12784"/>
          <a:stretch/>
        </p:blipFill>
        <p:spPr>
          <a:xfrm>
            <a:off x="3493039" y="8933327"/>
            <a:ext cx="3263937" cy="1926304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A7E7948D-432D-44C2-AD14-346EFDC35A27}"/>
              </a:ext>
            </a:extLst>
          </p:cNvPr>
          <p:cNvSpPr txBox="1"/>
          <p:nvPr/>
        </p:nvSpPr>
        <p:spPr>
          <a:xfrm>
            <a:off x="75627" y="1205228"/>
            <a:ext cx="37793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ean case-mix 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djusted mortality (%)</a:t>
            </a:r>
            <a:endParaRPr lang="nl-NL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CE4A749-C9F9-4B4F-8612-8864D31EFDE0}"/>
              </a:ext>
            </a:extLst>
          </p:cNvPr>
          <p:cNvSpPr txBox="1"/>
          <p:nvPr/>
        </p:nvSpPr>
        <p:spPr>
          <a:xfrm>
            <a:off x="19559" y="5757059"/>
            <a:ext cx="37793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ean case-mix 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djusted mortality (%)</a:t>
            </a:r>
            <a:endParaRPr lang="nl-NL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477A5A5-0DDD-43F3-8729-B784B0CDEFE4}"/>
              </a:ext>
            </a:extLst>
          </p:cNvPr>
          <p:cNvSpPr txBox="1"/>
          <p:nvPr/>
        </p:nvSpPr>
        <p:spPr>
          <a:xfrm>
            <a:off x="79666" y="8443450"/>
            <a:ext cx="37793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ean case-mix 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djusted mortality (%)</a:t>
            </a:r>
            <a:endParaRPr lang="nl-NL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EF75047-9E94-4427-82EF-D0FF381A6002}"/>
              </a:ext>
            </a:extLst>
          </p:cNvPr>
          <p:cNvSpPr txBox="1"/>
          <p:nvPr/>
        </p:nvSpPr>
        <p:spPr>
          <a:xfrm>
            <a:off x="1800624" y="1258198"/>
            <a:ext cx="41874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iomarkers of renal function and homeostasis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03715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17</TotalTime>
  <Words>74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ndel, B.G.J. (SEH)</dc:creator>
  <cp:lastModifiedBy>Candel, B.G.J. (SEH)</cp:lastModifiedBy>
  <cp:revision>83</cp:revision>
  <dcterms:created xsi:type="dcterms:W3CDTF">2020-05-19T06:05:31Z</dcterms:created>
  <dcterms:modified xsi:type="dcterms:W3CDTF">2021-12-19T16:51:32Z</dcterms:modified>
</cp:coreProperties>
</file>